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>
        <p:scale>
          <a:sx n="62" d="100"/>
          <a:sy n="62" d="100"/>
        </p:scale>
        <p:origin x="762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2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85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08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391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037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7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29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462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342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847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878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5CC59C-4CCC-49B1-801F-23D72E848F16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E817E4-E9AE-40C4-A09F-0C0CA21C2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649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2204" y="6116491"/>
            <a:ext cx="10515600" cy="436990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erformance metrics of the three CNN model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499"/>
            <a:ext cx="12085985" cy="6042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3646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2204" y="6116491"/>
            <a:ext cx="10515600" cy="436990"/>
          </a:xfrm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 accuracy and precisio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9423"/>
            <a:ext cx="11974561" cy="6017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6212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2204" y="6116491"/>
            <a:ext cx="10515600" cy="436990"/>
          </a:xfrm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 recall and F1-scor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465" y="217284"/>
            <a:ext cx="12038114" cy="5899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580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5057" y="6170279"/>
            <a:ext cx="11740562" cy="436990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nfusion matrix of Plasmo3Net evaluation of the NIH data set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7" t="7388" r="12010" b="3676"/>
          <a:stretch/>
        </p:blipFill>
        <p:spPr>
          <a:xfrm>
            <a:off x="2266791" y="276625"/>
            <a:ext cx="7069310" cy="5740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709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44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10</cp:revision>
  <dcterms:created xsi:type="dcterms:W3CDTF">2024-06-22T16:39:35Z</dcterms:created>
  <dcterms:modified xsi:type="dcterms:W3CDTF">2024-12-05T21:36:22Z</dcterms:modified>
</cp:coreProperties>
</file>